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8" d="100"/>
          <a:sy n="78" d="100"/>
        </p:scale>
        <p:origin x="-1452" y="-84"/>
      </p:cViewPr>
      <p:guideLst>
        <p:guide orient="horz" pos="2880"/>
        <p:guide pos="4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3C1F0-1321-4F96-82D4-98D4206F730F}" type="datetimeFigureOut">
              <a:rPr lang="en-GB" smtClean="0"/>
              <a:pPr/>
              <a:t>27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70E60-5F9C-4498-9DFE-9741B2D3A49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316992" y="7205472"/>
            <a:ext cx="619353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 pitchFamily="34" charset="0"/>
                <a:cs typeface="Arial" pitchFamily="34" charset="0"/>
              </a:rPr>
              <a:t>Supplementary Figure 3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LIM1863 human CRC cells cultured in the absence (A) or presence (B) of  2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/ml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GF</a:t>
            </a:r>
            <a:r>
              <a:rPr lang="en-GB" sz="1200" dirty="0" err="1" smtClean="0">
                <a:latin typeface="Symbol" pitchFamily="18" charset="2"/>
                <a:cs typeface="Arial" pitchFamily="34" charset="0"/>
              </a:rPr>
              <a:t>b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LIM1863 human CRC cells grow as floating, disorganised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mutli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-cellular colonies.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TGF</a:t>
            </a:r>
            <a:r>
              <a:rPr lang="en-GB" sz="1200" dirty="0" err="1" smtClean="0">
                <a:latin typeface="Symbol" pitchFamily="18" charset="2"/>
                <a:cs typeface="Arial" pitchFamily="34" charset="0"/>
              </a:rPr>
              <a:t>b</a:t>
            </a:r>
            <a:r>
              <a:rPr lang="en-GB" sz="1200" dirty="0" smtClean="0">
                <a:latin typeface="Symbol" pitchFamily="18" charset="2"/>
                <a:cs typeface="Arial" pitchFamily="34" charset="0"/>
              </a:rPr>
              <a:t>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induces profound </a:t>
            </a:r>
            <a:r>
              <a:rPr lang="en-GB" sz="1200" smtClean="0">
                <a:latin typeface="Arial" pitchFamily="34" charset="0"/>
                <a:cs typeface="Arial" pitchFamily="34" charset="0"/>
              </a:rPr>
              <a:t>morphological </a:t>
            </a:r>
            <a:r>
              <a:rPr lang="en-GB" sz="1200" smtClean="0">
                <a:latin typeface="Arial" pitchFamily="34" charset="0"/>
                <a:cs typeface="Arial" pitchFamily="34" charset="0"/>
              </a:rPr>
              <a:t>changes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whereby colonies adhere to plastic and cells spread out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radially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in a monolayer having assumed a ‘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mesenchymal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’ phenotype with a ‘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fibroblastoid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‘ appearance and loss of membranous E-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adherin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localisation. For the EMT assay, a region of interest was drawn around the perimeter of each adherent colony (B) in order to measure each individual colony area.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1121664" y="207264"/>
            <a:ext cx="4682456" cy="3443288"/>
            <a:chOff x="1121664" y="207264"/>
            <a:chExt cx="4682456" cy="3443288"/>
          </a:xfrm>
        </p:grpSpPr>
        <p:grpSp>
          <p:nvGrpSpPr>
            <p:cNvPr id="16" name="Group 15"/>
            <p:cNvGrpSpPr/>
            <p:nvPr/>
          </p:nvGrpSpPr>
          <p:grpSpPr>
            <a:xfrm>
              <a:off x="1135282" y="219964"/>
              <a:ext cx="4668838" cy="3430588"/>
              <a:chOff x="1135282" y="622300"/>
              <a:chExt cx="4668838" cy="3430588"/>
            </a:xfrm>
          </p:grpSpPr>
          <p:pic>
            <p:nvPicPr>
              <p:cNvPr id="4" name="Picture 57" descr="day 6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135282" y="622300"/>
                <a:ext cx="4567238" cy="343058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</p:pic>
          <p:sp>
            <p:nvSpPr>
              <p:cNvPr id="5" name="Line 3"/>
              <p:cNvSpPr>
                <a:spLocks noChangeShapeType="1"/>
              </p:cNvSpPr>
              <p:nvPr/>
            </p:nvSpPr>
            <p:spPr bwMode="auto">
              <a:xfrm>
                <a:off x="4896070" y="3656013"/>
                <a:ext cx="601662" cy="1587"/>
              </a:xfrm>
              <a:prstGeom prst="line">
                <a:avLst/>
              </a:prstGeom>
              <a:noFill/>
              <a:ln w="317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" name="Text Box 4"/>
              <p:cNvSpPr txBox="1">
                <a:spLocks noChangeArrowheads="1"/>
              </p:cNvSpPr>
              <p:nvPr/>
            </p:nvSpPr>
            <p:spPr bwMode="auto">
              <a:xfrm>
                <a:off x="4896070" y="3656013"/>
                <a:ext cx="908050" cy="285750"/>
              </a:xfrm>
              <a:prstGeom prst="rect">
                <a:avLst/>
              </a:prstGeom>
              <a:solidFill>
                <a:srgbClr val="FFFFFF">
                  <a:alpha val="0"/>
                </a:srgbClr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300 µm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1121664" y="207264"/>
              <a:ext cx="402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GB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1115568" y="3712464"/>
            <a:ext cx="4682456" cy="3439672"/>
            <a:chOff x="1115568" y="3712464"/>
            <a:chExt cx="4682456" cy="3439672"/>
          </a:xfrm>
        </p:grpSpPr>
        <p:grpSp>
          <p:nvGrpSpPr>
            <p:cNvPr id="17" name="Group 16"/>
            <p:cNvGrpSpPr/>
            <p:nvPr/>
          </p:nvGrpSpPr>
          <p:grpSpPr>
            <a:xfrm>
              <a:off x="1128928" y="3723136"/>
              <a:ext cx="4669096" cy="3429000"/>
              <a:chOff x="1128928" y="4125472"/>
              <a:chExt cx="4669096" cy="3429000"/>
            </a:xfrm>
          </p:grpSpPr>
          <p:pic>
            <p:nvPicPr>
              <p:cNvPr id="7" name="Picture 56" descr="day6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128928" y="4125472"/>
                <a:ext cx="4572000" cy="34290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</p:pic>
          <p:sp>
            <p:nvSpPr>
              <p:cNvPr id="14" name="Line 3"/>
              <p:cNvSpPr>
                <a:spLocks noChangeShapeType="1"/>
              </p:cNvSpPr>
              <p:nvPr/>
            </p:nvSpPr>
            <p:spPr bwMode="auto">
              <a:xfrm>
                <a:off x="4889974" y="7100253"/>
                <a:ext cx="601662" cy="1587"/>
              </a:xfrm>
              <a:prstGeom prst="line">
                <a:avLst/>
              </a:prstGeom>
              <a:noFill/>
              <a:ln w="3175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5" name="Text Box 4"/>
              <p:cNvSpPr txBox="1">
                <a:spLocks noChangeArrowheads="1"/>
              </p:cNvSpPr>
              <p:nvPr/>
            </p:nvSpPr>
            <p:spPr bwMode="auto">
              <a:xfrm>
                <a:off x="4889974" y="7112445"/>
                <a:ext cx="908050" cy="285750"/>
              </a:xfrm>
              <a:prstGeom prst="rect">
                <a:avLst/>
              </a:prstGeom>
              <a:solidFill>
                <a:srgbClr val="FFFFFF">
                  <a:alpha val="0"/>
                </a:srgbClr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GB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Calibri" pitchFamily="34" charset="0"/>
                    <a:cs typeface="Arial" pitchFamily="34" charset="0"/>
                  </a:rPr>
                  <a:t>300 µm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9" name="Freeform 18"/>
            <p:cNvSpPr/>
            <p:nvPr/>
          </p:nvSpPr>
          <p:spPr>
            <a:xfrm>
              <a:off x="3868458" y="3864864"/>
              <a:ext cx="1630858" cy="1438656"/>
            </a:xfrm>
            <a:custGeom>
              <a:avLst/>
              <a:gdLst>
                <a:gd name="connsiteX0" fmla="*/ 203670 w 1630858"/>
                <a:gd name="connsiteY0" fmla="*/ 268224 h 1438656"/>
                <a:gd name="connsiteX1" fmla="*/ 154902 w 1630858"/>
                <a:gd name="connsiteY1" fmla="*/ 329184 h 1438656"/>
                <a:gd name="connsiteX2" fmla="*/ 106134 w 1630858"/>
                <a:gd name="connsiteY2" fmla="*/ 402336 h 1438656"/>
                <a:gd name="connsiteX3" fmla="*/ 69558 w 1630858"/>
                <a:gd name="connsiteY3" fmla="*/ 560832 h 1438656"/>
                <a:gd name="connsiteX4" fmla="*/ 57366 w 1630858"/>
                <a:gd name="connsiteY4" fmla="*/ 609600 h 1438656"/>
                <a:gd name="connsiteX5" fmla="*/ 45174 w 1630858"/>
                <a:gd name="connsiteY5" fmla="*/ 646176 h 1438656"/>
                <a:gd name="connsiteX6" fmla="*/ 20790 w 1630858"/>
                <a:gd name="connsiteY6" fmla="*/ 780288 h 1438656"/>
                <a:gd name="connsiteX7" fmla="*/ 8598 w 1630858"/>
                <a:gd name="connsiteY7" fmla="*/ 816864 h 1438656"/>
                <a:gd name="connsiteX8" fmla="*/ 20790 w 1630858"/>
                <a:gd name="connsiteY8" fmla="*/ 902208 h 1438656"/>
                <a:gd name="connsiteX9" fmla="*/ 57366 w 1630858"/>
                <a:gd name="connsiteY9" fmla="*/ 938784 h 1438656"/>
                <a:gd name="connsiteX10" fmla="*/ 118326 w 1630858"/>
                <a:gd name="connsiteY10" fmla="*/ 1121664 h 1438656"/>
                <a:gd name="connsiteX11" fmla="*/ 142710 w 1630858"/>
                <a:gd name="connsiteY11" fmla="*/ 1158240 h 1438656"/>
                <a:gd name="connsiteX12" fmla="*/ 252438 w 1630858"/>
                <a:gd name="connsiteY12" fmla="*/ 1194816 h 1438656"/>
                <a:gd name="connsiteX13" fmla="*/ 289014 w 1630858"/>
                <a:gd name="connsiteY13" fmla="*/ 1207008 h 1438656"/>
                <a:gd name="connsiteX14" fmla="*/ 276822 w 1630858"/>
                <a:gd name="connsiteY14" fmla="*/ 1243584 h 1438656"/>
                <a:gd name="connsiteX15" fmla="*/ 289014 w 1630858"/>
                <a:gd name="connsiteY15" fmla="*/ 1304544 h 1438656"/>
                <a:gd name="connsiteX16" fmla="*/ 459702 w 1630858"/>
                <a:gd name="connsiteY16" fmla="*/ 1365504 h 1438656"/>
                <a:gd name="connsiteX17" fmla="*/ 545046 w 1630858"/>
                <a:gd name="connsiteY17" fmla="*/ 1389888 h 1438656"/>
                <a:gd name="connsiteX18" fmla="*/ 618198 w 1630858"/>
                <a:gd name="connsiteY18" fmla="*/ 1377696 h 1438656"/>
                <a:gd name="connsiteX19" fmla="*/ 691350 w 1630858"/>
                <a:gd name="connsiteY19" fmla="*/ 1328928 h 1438656"/>
                <a:gd name="connsiteX20" fmla="*/ 727926 w 1630858"/>
                <a:gd name="connsiteY20" fmla="*/ 1304544 h 1438656"/>
                <a:gd name="connsiteX21" fmla="*/ 801078 w 1630858"/>
                <a:gd name="connsiteY21" fmla="*/ 1280160 h 1438656"/>
                <a:gd name="connsiteX22" fmla="*/ 971766 w 1630858"/>
                <a:gd name="connsiteY22" fmla="*/ 1316736 h 1438656"/>
                <a:gd name="connsiteX23" fmla="*/ 996150 w 1630858"/>
                <a:gd name="connsiteY23" fmla="*/ 1353312 h 1438656"/>
                <a:gd name="connsiteX24" fmla="*/ 1105878 w 1630858"/>
                <a:gd name="connsiteY24" fmla="*/ 1414272 h 1438656"/>
                <a:gd name="connsiteX25" fmla="*/ 1276566 w 1630858"/>
                <a:gd name="connsiteY25" fmla="*/ 1426464 h 1438656"/>
                <a:gd name="connsiteX26" fmla="*/ 1313142 w 1630858"/>
                <a:gd name="connsiteY26" fmla="*/ 1438656 h 1438656"/>
                <a:gd name="connsiteX27" fmla="*/ 1398486 w 1630858"/>
                <a:gd name="connsiteY27" fmla="*/ 1426464 h 1438656"/>
                <a:gd name="connsiteX28" fmla="*/ 1471638 w 1630858"/>
                <a:gd name="connsiteY28" fmla="*/ 1365504 h 1438656"/>
                <a:gd name="connsiteX29" fmla="*/ 1508214 w 1630858"/>
                <a:gd name="connsiteY29" fmla="*/ 1353312 h 1438656"/>
                <a:gd name="connsiteX30" fmla="*/ 1544790 w 1630858"/>
                <a:gd name="connsiteY30" fmla="*/ 1316736 h 1438656"/>
                <a:gd name="connsiteX31" fmla="*/ 1581366 w 1630858"/>
                <a:gd name="connsiteY31" fmla="*/ 1292352 h 1438656"/>
                <a:gd name="connsiteX32" fmla="*/ 1605750 w 1630858"/>
                <a:gd name="connsiteY32" fmla="*/ 1243584 h 1438656"/>
                <a:gd name="connsiteX33" fmla="*/ 1630134 w 1630858"/>
                <a:gd name="connsiteY33" fmla="*/ 1207008 h 1438656"/>
                <a:gd name="connsiteX34" fmla="*/ 1617942 w 1630858"/>
                <a:gd name="connsiteY34" fmla="*/ 1085088 h 1438656"/>
                <a:gd name="connsiteX35" fmla="*/ 1581366 w 1630858"/>
                <a:gd name="connsiteY35" fmla="*/ 1060704 h 1438656"/>
                <a:gd name="connsiteX36" fmla="*/ 1569174 w 1630858"/>
                <a:gd name="connsiteY36" fmla="*/ 1024128 h 1438656"/>
                <a:gd name="connsiteX37" fmla="*/ 1483830 w 1630858"/>
                <a:gd name="connsiteY37" fmla="*/ 804672 h 1438656"/>
                <a:gd name="connsiteX38" fmla="*/ 1447254 w 1630858"/>
                <a:gd name="connsiteY38" fmla="*/ 768096 h 1438656"/>
                <a:gd name="connsiteX39" fmla="*/ 1398486 w 1630858"/>
                <a:gd name="connsiteY39" fmla="*/ 694944 h 1438656"/>
                <a:gd name="connsiteX40" fmla="*/ 1374102 w 1630858"/>
                <a:gd name="connsiteY40" fmla="*/ 609600 h 1438656"/>
                <a:gd name="connsiteX41" fmla="*/ 1337526 w 1630858"/>
                <a:gd name="connsiteY41" fmla="*/ 585216 h 1438656"/>
                <a:gd name="connsiteX42" fmla="*/ 1300950 w 1630858"/>
                <a:gd name="connsiteY42" fmla="*/ 536448 h 1438656"/>
                <a:gd name="connsiteX43" fmla="*/ 1276566 w 1630858"/>
                <a:gd name="connsiteY43" fmla="*/ 499872 h 1438656"/>
                <a:gd name="connsiteX44" fmla="*/ 1239990 w 1630858"/>
                <a:gd name="connsiteY44" fmla="*/ 475488 h 1438656"/>
                <a:gd name="connsiteX45" fmla="*/ 1215606 w 1630858"/>
                <a:gd name="connsiteY45" fmla="*/ 438912 h 1438656"/>
                <a:gd name="connsiteX46" fmla="*/ 1069302 w 1630858"/>
                <a:gd name="connsiteY46" fmla="*/ 390144 h 1438656"/>
                <a:gd name="connsiteX47" fmla="*/ 983958 w 1630858"/>
                <a:gd name="connsiteY47" fmla="*/ 329184 h 1438656"/>
                <a:gd name="connsiteX48" fmla="*/ 959574 w 1630858"/>
                <a:gd name="connsiteY48" fmla="*/ 292608 h 1438656"/>
                <a:gd name="connsiteX49" fmla="*/ 874230 w 1630858"/>
                <a:gd name="connsiteY49" fmla="*/ 256032 h 1438656"/>
                <a:gd name="connsiteX50" fmla="*/ 813270 w 1630858"/>
                <a:gd name="connsiteY50" fmla="*/ 182880 h 1438656"/>
                <a:gd name="connsiteX51" fmla="*/ 764502 w 1630858"/>
                <a:gd name="connsiteY51" fmla="*/ 36576 h 1438656"/>
                <a:gd name="connsiteX52" fmla="*/ 703542 w 1630858"/>
                <a:gd name="connsiteY52" fmla="*/ 85344 h 1438656"/>
                <a:gd name="connsiteX53" fmla="*/ 666966 w 1630858"/>
                <a:gd name="connsiteY53" fmla="*/ 97536 h 1438656"/>
                <a:gd name="connsiteX54" fmla="*/ 630390 w 1630858"/>
                <a:gd name="connsiteY54" fmla="*/ 85344 h 1438656"/>
                <a:gd name="connsiteX55" fmla="*/ 557238 w 1630858"/>
                <a:gd name="connsiteY55" fmla="*/ 24384 h 1438656"/>
                <a:gd name="connsiteX56" fmla="*/ 508470 w 1630858"/>
                <a:gd name="connsiteY56" fmla="*/ 12192 h 1438656"/>
                <a:gd name="connsiteX57" fmla="*/ 471894 w 1630858"/>
                <a:gd name="connsiteY57" fmla="*/ 0 h 1438656"/>
                <a:gd name="connsiteX58" fmla="*/ 435318 w 1630858"/>
                <a:gd name="connsiteY58" fmla="*/ 36576 h 1438656"/>
                <a:gd name="connsiteX59" fmla="*/ 423126 w 1630858"/>
                <a:gd name="connsiteY59" fmla="*/ 73152 h 1438656"/>
                <a:gd name="connsiteX60" fmla="*/ 386550 w 1630858"/>
                <a:gd name="connsiteY60" fmla="*/ 97536 h 1438656"/>
                <a:gd name="connsiteX61" fmla="*/ 349974 w 1630858"/>
                <a:gd name="connsiteY61" fmla="*/ 134112 h 1438656"/>
                <a:gd name="connsiteX62" fmla="*/ 313398 w 1630858"/>
                <a:gd name="connsiteY62" fmla="*/ 158496 h 1438656"/>
                <a:gd name="connsiteX63" fmla="*/ 276822 w 1630858"/>
                <a:gd name="connsiteY63" fmla="*/ 195072 h 1438656"/>
                <a:gd name="connsiteX64" fmla="*/ 240246 w 1630858"/>
                <a:gd name="connsiteY64" fmla="*/ 207264 h 1438656"/>
                <a:gd name="connsiteX65" fmla="*/ 203670 w 1630858"/>
                <a:gd name="connsiteY65" fmla="*/ 268224 h 14386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</a:cxnLst>
              <a:rect l="l" t="t" r="r" b="b"/>
              <a:pathLst>
                <a:path w="1630858" h="1438656">
                  <a:moveTo>
                    <a:pt x="203670" y="268224"/>
                  </a:moveTo>
                  <a:cubicBezTo>
                    <a:pt x="189446" y="288544"/>
                    <a:pt x="189543" y="266830"/>
                    <a:pt x="154902" y="329184"/>
                  </a:cubicBezTo>
                  <a:cubicBezTo>
                    <a:pt x="140670" y="354802"/>
                    <a:pt x="106134" y="402336"/>
                    <a:pt x="106134" y="402336"/>
                  </a:cubicBezTo>
                  <a:cubicBezTo>
                    <a:pt x="46378" y="641360"/>
                    <a:pt x="107087" y="391953"/>
                    <a:pt x="69558" y="560832"/>
                  </a:cubicBezTo>
                  <a:cubicBezTo>
                    <a:pt x="65923" y="577189"/>
                    <a:pt x="61969" y="593488"/>
                    <a:pt x="57366" y="609600"/>
                  </a:cubicBezTo>
                  <a:cubicBezTo>
                    <a:pt x="53835" y="621957"/>
                    <a:pt x="47962" y="633631"/>
                    <a:pt x="45174" y="646176"/>
                  </a:cubicBezTo>
                  <a:cubicBezTo>
                    <a:pt x="23434" y="744005"/>
                    <a:pt x="42978" y="691536"/>
                    <a:pt x="20790" y="780288"/>
                  </a:cubicBezTo>
                  <a:cubicBezTo>
                    <a:pt x="17673" y="792756"/>
                    <a:pt x="12662" y="804672"/>
                    <a:pt x="8598" y="816864"/>
                  </a:cubicBezTo>
                  <a:cubicBezTo>
                    <a:pt x="12662" y="845312"/>
                    <a:pt x="10117" y="875527"/>
                    <a:pt x="20790" y="902208"/>
                  </a:cubicBezTo>
                  <a:cubicBezTo>
                    <a:pt x="27194" y="918217"/>
                    <a:pt x="51914" y="922427"/>
                    <a:pt x="57366" y="938784"/>
                  </a:cubicBezTo>
                  <a:cubicBezTo>
                    <a:pt x="134507" y="1170208"/>
                    <a:pt x="0" y="944175"/>
                    <a:pt x="118326" y="1121664"/>
                  </a:cubicBezTo>
                  <a:cubicBezTo>
                    <a:pt x="126454" y="1133856"/>
                    <a:pt x="128809" y="1153606"/>
                    <a:pt x="142710" y="1158240"/>
                  </a:cubicBezTo>
                  <a:lnTo>
                    <a:pt x="252438" y="1194816"/>
                  </a:lnTo>
                  <a:lnTo>
                    <a:pt x="289014" y="1207008"/>
                  </a:lnTo>
                  <a:cubicBezTo>
                    <a:pt x="284950" y="1219200"/>
                    <a:pt x="276822" y="1230733"/>
                    <a:pt x="276822" y="1243584"/>
                  </a:cubicBezTo>
                  <a:cubicBezTo>
                    <a:pt x="276822" y="1264306"/>
                    <a:pt x="276292" y="1288187"/>
                    <a:pt x="289014" y="1304544"/>
                  </a:cubicBezTo>
                  <a:cubicBezTo>
                    <a:pt x="338097" y="1367650"/>
                    <a:pt x="390477" y="1353966"/>
                    <a:pt x="459702" y="1365504"/>
                  </a:cubicBezTo>
                  <a:cubicBezTo>
                    <a:pt x="490320" y="1370607"/>
                    <a:pt x="516056" y="1380225"/>
                    <a:pt x="545046" y="1389888"/>
                  </a:cubicBezTo>
                  <a:cubicBezTo>
                    <a:pt x="569430" y="1385824"/>
                    <a:pt x="595379" y="1387204"/>
                    <a:pt x="618198" y="1377696"/>
                  </a:cubicBezTo>
                  <a:cubicBezTo>
                    <a:pt x="645250" y="1366424"/>
                    <a:pt x="666966" y="1345184"/>
                    <a:pt x="691350" y="1328928"/>
                  </a:cubicBezTo>
                  <a:cubicBezTo>
                    <a:pt x="703542" y="1320800"/>
                    <a:pt x="714025" y="1309178"/>
                    <a:pt x="727926" y="1304544"/>
                  </a:cubicBezTo>
                  <a:lnTo>
                    <a:pt x="801078" y="1280160"/>
                  </a:lnTo>
                  <a:cubicBezTo>
                    <a:pt x="904318" y="1348986"/>
                    <a:pt x="733259" y="1243349"/>
                    <a:pt x="971766" y="1316736"/>
                  </a:cubicBezTo>
                  <a:cubicBezTo>
                    <a:pt x="985771" y="1321045"/>
                    <a:pt x="985123" y="1343663"/>
                    <a:pt x="996150" y="1353312"/>
                  </a:cubicBezTo>
                  <a:cubicBezTo>
                    <a:pt x="1015123" y="1369913"/>
                    <a:pt x="1069948" y="1410045"/>
                    <a:pt x="1105878" y="1414272"/>
                  </a:cubicBezTo>
                  <a:cubicBezTo>
                    <a:pt x="1162528" y="1420937"/>
                    <a:pt x="1219670" y="1422400"/>
                    <a:pt x="1276566" y="1426464"/>
                  </a:cubicBezTo>
                  <a:cubicBezTo>
                    <a:pt x="1288758" y="1430528"/>
                    <a:pt x="1300291" y="1438656"/>
                    <a:pt x="1313142" y="1438656"/>
                  </a:cubicBezTo>
                  <a:cubicBezTo>
                    <a:pt x="1341879" y="1438656"/>
                    <a:pt x="1370961" y="1434721"/>
                    <a:pt x="1398486" y="1426464"/>
                  </a:cubicBezTo>
                  <a:cubicBezTo>
                    <a:pt x="1434749" y="1415585"/>
                    <a:pt x="1441951" y="1385296"/>
                    <a:pt x="1471638" y="1365504"/>
                  </a:cubicBezTo>
                  <a:cubicBezTo>
                    <a:pt x="1482331" y="1358375"/>
                    <a:pt x="1496022" y="1357376"/>
                    <a:pt x="1508214" y="1353312"/>
                  </a:cubicBezTo>
                  <a:cubicBezTo>
                    <a:pt x="1520406" y="1341120"/>
                    <a:pt x="1531544" y="1327774"/>
                    <a:pt x="1544790" y="1316736"/>
                  </a:cubicBezTo>
                  <a:cubicBezTo>
                    <a:pt x="1556047" y="1307355"/>
                    <a:pt x="1571985" y="1303609"/>
                    <a:pt x="1581366" y="1292352"/>
                  </a:cubicBezTo>
                  <a:cubicBezTo>
                    <a:pt x="1593001" y="1278390"/>
                    <a:pt x="1596733" y="1259364"/>
                    <a:pt x="1605750" y="1243584"/>
                  </a:cubicBezTo>
                  <a:cubicBezTo>
                    <a:pt x="1613020" y="1230862"/>
                    <a:pt x="1622006" y="1219200"/>
                    <a:pt x="1630134" y="1207008"/>
                  </a:cubicBezTo>
                  <a:cubicBezTo>
                    <a:pt x="1626070" y="1166368"/>
                    <a:pt x="1630858" y="1123835"/>
                    <a:pt x="1617942" y="1085088"/>
                  </a:cubicBezTo>
                  <a:cubicBezTo>
                    <a:pt x="1613308" y="1071187"/>
                    <a:pt x="1590520" y="1072146"/>
                    <a:pt x="1581366" y="1060704"/>
                  </a:cubicBezTo>
                  <a:cubicBezTo>
                    <a:pt x="1573338" y="1050669"/>
                    <a:pt x="1573238" y="1036320"/>
                    <a:pt x="1569174" y="1024128"/>
                  </a:cubicBezTo>
                  <a:cubicBezTo>
                    <a:pt x="1554118" y="843459"/>
                    <a:pt x="1591586" y="912428"/>
                    <a:pt x="1483830" y="804672"/>
                  </a:cubicBezTo>
                  <a:cubicBezTo>
                    <a:pt x="1471638" y="792480"/>
                    <a:pt x="1456818" y="782442"/>
                    <a:pt x="1447254" y="768096"/>
                  </a:cubicBezTo>
                  <a:lnTo>
                    <a:pt x="1398486" y="694944"/>
                  </a:lnTo>
                  <a:cubicBezTo>
                    <a:pt x="1397689" y="691758"/>
                    <a:pt x="1380462" y="617550"/>
                    <a:pt x="1374102" y="609600"/>
                  </a:cubicBezTo>
                  <a:cubicBezTo>
                    <a:pt x="1364948" y="598158"/>
                    <a:pt x="1347887" y="595577"/>
                    <a:pt x="1337526" y="585216"/>
                  </a:cubicBezTo>
                  <a:cubicBezTo>
                    <a:pt x="1323158" y="570848"/>
                    <a:pt x="1312761" y="552983"/>
                    <a:pt x="1300950" y="536448"/>
                  </a:cubicBezTo>
                  <a:cubicBezTo>
                    <a:pt x="1292433" y="524524"/>
                    <a:pt x="1286927" y="510233"/>
                    <a:pt x="1276566" y="499872"/>
                  </a:cubicBezTo>
                  <a:cubicBezTo>
                    <a:pt x="1266205" y="489511"/>
                    <a:pt x="1252182" y="483616"/>
                    <a:pt x="1239990" y="475488"/>
                  </a:cubicBezTo>
                  <a:cubicBezTo>
                    <a:pt x="1231862" y="463296"/>
                    <a:pt x="1225967" y="449273"/>
                    <a:pt x="1215606" y="438912"/>
                  </a:cubicBezTo>
                  <a:cubicBezTo>
                    <a:pt x="1177807" y="401113"/>
                    <a:pt x="1117767" y="398222"/>
                    <a:pt x="1069302" y="390144"/>
                  </a:cubicBezTo>
                  <a:cubicBezTo>
                    <a:pt x="1048534" y="376299"/>
                    <a:pt x="999081" y="344307"/>
                    <a:pt x="983958" y="329184"/>
                  </a:cubicBezTo>
                  <a:cubicBezTo>
                    <a:pt x="973597" y="318823"/>
                    <a:pt x="969935" y="302969"/>
                    <a:pt x="959574" y="292608"/>
                  </a:cubicBezTo>
                  <a:cubicBezTo>
                    <a:pt x="931508" y="264542"/>
                    <a:pt x="911538" y="265359"/>
                    <a:pt x="874230" y="256032"/>
                  </a:cubicBezTo>
                  <a:cubicBezTo>
                    <a:pt x="861792" y="243594"/>
                    <a:pt x="817899" y="204483"/>
                    <a:pt x="813270" y="182880"/>
                  </a:cubicBezTo>
                  <a:cubicBezTo>
                    <a:pt x="780395" y="29463"/>
                    <a:pt x="849251" y="64826"/>
                    <a:pt x="764502" y="36576"/>
                  </a:cubicBezTo>
                  <a:cubicBezTo>
                    <a:pt x="672567" y="67221"/>
                    <a:pt x="782324" y="22319"/>
                    <a:pt x="703542" y="85344"/>
                  </a:cubicBezTo>
                  <a:cubicBezTo>
                    <a:pt x="693507" y="93372"/>
                    <a:pt x="679158" y="93472"/>
                    <a:pt x="666966" y="97536"/>
                  </a:cubicBezTo>
                  <a:cubicBezTo>
                    <a:pt x="654774" y="93472"/>
                    <a:pt x="641083" y="92473"/>
                    <a:pt x="630390" y="85344"/>
                  </a:cubicBezTo>
                  <a:cubicBezTo>
                    <a:pt x="577661" y="50191"/>
                    <a:pt x="613083" y="48317"/>
                    <a:pt x="557238" y="24384"/>
                  </a:cubicBezTo>
                  <a:cubicBezTo>
                    <a:pt x="541837" y="17783"/>
                    <a:pt x="524582" y="16795"/>
                    <a:pt x="508470" y="12192"/>
                  </a:cubicBezTo>
                  <a:cubicBezTo>
                    <a:pt x="496113" y="8661"/>
                    <a:pt x="484086" y="4064"/>
                    <a:pt x="471894" y="0"/>
                  </a:cubicBezTo>
                  <a:cubicBezTo>
                    <a:pt x="459702" y="12192"/>
                    <a:pt x="444882" y="22230"/>
                    <a:pt x="435318" y="36576"/>
                  </a:cubicBezTo>
                  <a:cubicBezTo>
                    <a:pt x="428189" y="47269"/>
                    <a:pt x="431154" y="63117"/>
                    <a:pt x="423126" y="73152"/>
                  </a:cubicBezTo>
                  <a:cubicBezTo>
                    <a:pt x="413972" y="84594"/>
                    <a:pt x="397807" y="88155"/>
                    <a:pt x="386550" y="97536"/>
                  </a:cubicBezTo>
                  <a:cubicBezTo>
                    <a:pt x="373304" y="108574"/>
                    <a:pt x="363220" y="123074"/>
                    <a:pt x="349974" y="134112"/>
                  </a:cubicBezTo>
                  <a:cubicBezTo>
                    <a:pt x="338717" y="143493"/>
                    <a:pt x="324655" y="149115"/>
                    <a:pt x="313398" y="158496"/>
                  </a:cubicBezTo>
                  <a:cubicBezTo>
                    <a:pt x="300152" y="169534"/>
                    <a:pt x="291168" y="185508"/>
                    <a:pt x="276822" y="195072"/>
                  </a:cubicBezTo>
                  <a:cubicBezTo>
                    <a:pt x="266129" y="202201"/>
                    <a:pt x="251741" y="201517"/>
                    <a:pt x="240246" y="207264"/>
                  </a:cubicBezTo>
                  <a:cubicBezTo>
                    <a:pt x="201013" y="226881"/>
                    <a:pt x="217894" y="247904"/>
                    <a:pt x="203670" y="268224"/>
                  </a:cubicBez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15568" y="3712464"/>
              <a:ext cx="4023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GB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11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Leed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dmah</dc:creator>
  <cp:lastModifiedBy>medmah</cp:lastModifiedBy>
  <cp:revision>11</cp:revision>
  <dcterms:created xsi:type="dcterms:W3CDTF">2012-04-10T11:00:00Z</dcterms:created>
  <dcterms:modified xsi:type="dcterms:W3CDTF">2012-07-27T12:28:32Z</dcterms:modified>
</cp:coreProperties>
</file>